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12192000" cy="13716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978"/>
    <p:restoredTop sz="94694"/>
  </p:normalViewPr>
  <p:slideViewPr>
    <p:cSldViewPr snapToGrid="0" snapToObjects="1">
      <p:cViewPr>
        <p:scale>
          <a:sx n="62" d="100"/>
          <a:sy n="62" d="100"/>
        </p:scale>
        <p:origin x="3112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4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/>
              <a:t>HeLa, iBRD4, 10nM dBET6, WB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4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0hr</c:v>
          </c:tx>
          <c:spPr>
            <a:solidFill>
              <a:schemeClr val="accent1">
                <a:lumMod val="5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Sheet1!$K$16,Sheet1!$K$18,Sheet1!$K$20,Sheet1!$K$22,Sheet1!$K$24)</c:f>
                <c:numCache>
                  <c:formatCode>General</c:formatCode>
                  <c:ptCount val="5"/>
                  <c:pt idx="0">
                    <c:v>0.59853827815189831</c:v>
                  </c:pt>
                  <c:pt idx="1">
                    <c:v>0.46751737957386119</c:v>
                  </c:pt>
                  <c:pt idx="2">
                    <c:v>0.4662256316712709</c:v>
                  </c:pt>
                  <c:pt idx="3">
                    <c:v>0.60253352213974543</c:v>
                  </c:pt>
                  <c:pt idx="4">
                    <c:v>0.31972426453266817</c:v>
                  </c:pt>
                </c:numCache>
              </c:numRef>
            </c:plus>
            <c:minus>
              <c:numRef>
                <c:f>(Sheet1!$K$16,Sheet1!$K$18,Sheet1!$K$20,Sheet1!$K$22,Sheet1!$K$24)</c:f>
                <c:numCache>
                  <c:formatCode>General</c:formatCode>
                  <c:ptCount val="5"/>
                  <c:pt idx="0">
                    <c:v>0.59853827815189831</c:v>
                  </c:pt>
                  <c:pt idx="1">
                    <c:v>0.46751737957386119</c:v>
                  </c:pt>
                  <c:pt idx="2">
                    <c:v>0.4662256316712709</c:v>
                  </c:pt>
                  <c:pt idx="3">
                    <c:v>0.60253352213974543</c:v>
                  </c:pt>
                  <c:pt idx="4">
                    <c:v>0.3197242645326681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Sheet1!$G$16,Sheet1!$G$18,Sheet1!$G$20,Sheet1!$G$22,Sheet1!$G$24)</c:f>
              <c:strCache>
                <c:ptCount val="5"/>
                <c:pt idx="0">
                  <c:v>Empty</c:v>
                </c:pt>
                <c:pt idx="1">
                  <c:v>A</c:v>
                </c:pt>
                <c:pt idx="2">
                  <c:v>C</c:v>
                </c:pt>
                <c:pt idx="3">
                  <c:v>A∆CTD</c:v>
                </c:pt>
                <c:pt idx="4">
                  <c:v>C∆ET</c:v>
                </c:pt>
              </c:strCache>
            </c:strRef>
          </c:cat>
          <c:val>
            <c:numRef>
              <c:f>(Sheet1!$J$16,Sheet1!$J$18,Sheet1!$J$20,Sheet1!$J$22,Sheet1!$J$24)</c:f>
              <c:numCache>
                <c:formatCode>General</c:formatCode>
                <c:ptCount val="5"/>
                <c:pt idx="0">
                  <c:v>3.4419868063639889</c:v>
                </c:pt>
                <c:pt idx="1">
                  <c:v>1.816977225672878</c:v>
                </c:pt>
                <c:pt idx="2">
                  <c:v>1.9205745669623997</c:v>
                </c:pt>
                <c:pt idx="3">
                  <c:v>4.0448901623686728</c:v>
                </c:pt>
                <c:pt idx="4">
                  <c:v>1.8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717-CD4D-B5D6-4EE00FD2715E}"/>
            </c:ext>
          </c:extLst>
        </c:ser>
        <c:ser>
          <c:idx val="1"/>
          <c:order val="1"/>
          <c:tx>
            <c:v>6hr</c:v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Sheet1!$K$17,Sheet1!$K$19,Sheet1!$K$21,Sheet1!$K$23,Sheet1!$K$25)</c:f>
                <c:numCache>
                  <c:formatCode>General</c:formatCode>
                  <c:ptCount val="5"/>
                  <c:pt idx="0">
                    <c:v>3.2596831422753656</c:v>
                  </c:pt>
                  <c:pt idx="1">
                    <c:v>0.45809283830855574</c:v>
                  </c:pt>
                  <c:pt idx="2">
                    <c:v>2.1991175591394043</c:v>
                  </c:pt>
                  <c:pt idx="3">
                    <c:v>0.82674007633730873</c:v>
                  </c:pt>
                  <c:pt idx="4">
                    <c:v>5.2374162229199959</c:v>
                  </c:pt>
                </c:numCache>
              </c:numRef>
            </c:plus>
            <c:minus>
              <c:numRef>
                <c:f>(Sheet1!$K$17,Sheet1!$K$19,Sheet1!$K$21,Sheet1!$K$23,Sheet1!$K$25)</c:f>
                <c:numCache>
                  <c:formatCode>General</c:formatCode>
                  <c:ptCount val="5"/>
                  <c:pt idx="0">
                    <c:v>3.2596831422753656</c:v>
                  </c:pt>
                  <c:pt idx="1">
                    <c:v>0.45809283830855574</c:v>
                  </c:pt>
                  <c:pt idx="2">
                    <c:v>2.1991175591394043</c:v>
                  </c:pt>
                  <c:pt idx="3">
                    <c:v>0.82674007633730873</c:v>
                  </c:pt>
                  <c:pt idx="4">
                    <c:v>5.237416222919995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Sheet1!$G$16,Sheet1!$G$18,Sheet1!$G$20,Sheet1!$G$22,Sheet1!$G$24)</c:f>
              <c:strCache>
                <c:ptCount val="5"/>
                <c:pt idx="0">
                  <c:v>Empty</c:v>
                </c:pt>
                <c:pt idx="1">
                  <c:v>A</c:v>
                </c:pt>
                <c:pt idx="2">
                  <c:v>C</c:v>
                </c:pt>
                <c:pt idx="3">
                  <c:v>A∆CTD</c:v>
                </c:pt>
                <c:pt idx="4">
                  <c:v>C∆ET</c:v>
                </c:pt>
              </c:strCache>
            </c:strRef>
          </c:cat>
          <c:val>
            <c:numRef>
              <c:f>(Sheet1!$J$17,Sheet1!$J$19,Sheet1!$J$21,Sheet1!$J$23,Sheet1!$J$25)</c:f>
              <c:numCache>
                <c:formatCode>General</c:formatCode>
                <c:ptCount val="5"/>
                <c:pt idx="0">
                  <c:v>18.301282051282051</c:v>
                </c:pt>
                <c:pt idx="1">
                  <c:v>1.7869955156950672</c:v>
                </c:pt>
                <c:pt idx="2">
                  <c:v>10.298368298368297</c:v>
                </c:pt>
                <c:pt idx="3">
                  <c:v>16.881542699724516</c:v>
                </c:pt>
                <c:pt idx="4">
                  <c:v>28.0147446024223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717-CD4D-B5D6-4EE00FD2715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5"/>
        <c:axId val="1038640031"/>
        <c:axId val="1038641663"/>
      </c:barChart>
      <c:catAx>
        <c:axId val="103864003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2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BRD4 Isoform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20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038641663"/>
        <c:crosses val="autoZero"/>
        <c:auto val="1"/>
        <c:lblAlgn val="ctr"/>
        <c:lblOffset val="100"/>
        <c:noMultiLvlLbl val="0"/>
      </c:catAx>
      <c:valAx>
        <c:axId val="103864166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2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𝛾H2AX Signal (a.u.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20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03864003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0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20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C0A548-B85D-0949-AF39-F812760CA77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2244726"/>
            <a:ext cx="9144000" cy="47752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AA27250-5CAA-FA42-8868-5524F823D4A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7204076"/>
            <a:ext cx="9144000" cy="3311524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371A77-21A4-2B4F-9375-C69A744646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11B2C1-1F86-8C4D-A04D-EBD4AF1AE7FC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44A425-8662-4F41-A31A-338A30DB3C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25C2BA-29D1-0640-A321-3605BF712A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08BED2-F256-7B49-A262-A1B89828E0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75205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D54D47-5B41-4549-A638-DE7ADEF928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8E2DF23-1635-5244-9FC1-006E5FC0802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890112-A70C-0845-A8C2-188B701286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11B2C1-1F86-8C4D-A04D-EBD4AF1AE7FC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FB052B-584A-A540-AE01-53B257B674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FD9FDB-0CE6-A24E-8489-2673649604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08BED2-F256-7B49-A262-A1B89828E0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18286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A822462-5D6D-FB43-9E3F-E8660794735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730250"/>
            <a:ext cx="2628900" cy="11623676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D13C9AD-0666-FA44-BB9A-C1026AF2271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730250"/>
            <a:ext cx="7734300" cy="1162367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AC0B8E-A220-5141-AACB-6A2B9964AA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11B2C1-1F86-8C4D-A04D-EBD4AF1AE7FC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2F32C1-9DAD-AC4A-A619-C0541FFA45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564A70-E4E1-9A4C-858F-04B360F732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08BED2-F256-7B49-A262-A1B89828E0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76835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C5D60F-644B-914B-8AA5-16DCB8506D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F94AD84-853F-724A-B4DB-8B6535F232C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746115-FC4C-0B42-8514-F529A6C530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11B2C1-1F86-8C4D-A04D-EBD4AF1AE7FC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511DF1-C7A6-004E-BF31-1B997C9842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4486C9-7639-794F-A10C-038FD390C6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08BED2-F256-7B49-A262-A1B89828E0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67321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B0EF3A-6B12-AC4F-98D2-700B58218E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3419477"/>
            <a:ext cx="10515600" cy="5705474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6858DE8-BF50-3B40-9002-087AE77F141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9178927"/>
            <a:ext cx="10515600" cy="3000374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4F86F0F-C18C-084C-B980-01D8FF8787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11B2C1-1F86-8C4D-A04D-EBD4AF1AE7FC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36CA37-9D3E-104B-B4AF-2D1FF1EFB2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273178-0936-184F-8B42-CAB0CB4000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08BED2-F256-7B49-A262-A1B89828E0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68696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35F213-7D90-EF49-AD93-6B27CE974C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8E317AB-7115-EB47-B840-4884E56064E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3651250"/>
            <a:ext cx="5181600" cy="87026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28E7346-829C-164E-9D81-A94F35CEA06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3651250"/>
            <a:ext cx="5181600" cy="87026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C2EF9C1-C815-4C49-9D1F-F11EE27175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11B2C1-1F86-8C4D-A04D-EBD4AF1AE7FC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43CC661-4951-E243-93FA-DD7272BBDB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5FB98A6-1D38-344C-83E6-FA9F31ECEF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08BED2-F256-7B49-A262-A1B89828E0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44921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948B88-E6B0-8D45-83C2-0A612D1109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730251"/>
            <a:ext cx="10515600" cy="2651126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CB23B38-A8FF-D64C-A219-0BBBF5F3B21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9" y="3362326"/>
            <a:ext cx="5157787" cy="164782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E28BA7A-4775-E444-A72C-C00B9AAA892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9" y="5010150"/>
            <a:ext cx="5157787" cy="73691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D255ECC-FE37-AC45-BC05-CCAB64B94E8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3362326"/>
            <a:ext cx="5183188" cy="164782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682E054-FB5B-A546-87D7-AFD088421A1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5010150"/>
            <a:ext cx="5183188" cy="73691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1E58289-9CD9-C245-B628-F7F0C5F191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11B2C1-1F86-8C4D-A04D-EBD4AF1AE7FC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E1D8618-ABB2-8441-8B2F-F276FA79C5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A44AC76-A67C-FA4A-B208-7598672A12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08BED2-F256-7B49-A262-A1B89828E0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76151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5A12AF-A83E-E947-9CFB-9E0160A800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3A8B091-2B61-5A4C-A193-8537E626D2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11B2C1-1F86-8C4D-A04D-EBD4AF1AE7FC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FD1A76F-4195-7F4B-8355-382D753798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D084A64-AA88-934A-86EF-E66BB7255E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08BED2-F256-7B49-A262-A1B89828E0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2839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09FF26E-EAEC-3A49-9F06-BDF0CB255F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11B2C1-1F86-8C4D-A04D-EBD4AF1AE7FC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6109D27-5D16-B943-AF87-CBB8B4E4FB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3742A13-3B00-7441-A3BF-830D11598A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08BED2-F256-7B49-A262-A1B89828E0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54550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B09BF8-3407-5F40-899A-53D4ECF19D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914400"/>
            <a:ext cx="3932237" cy="32004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741CD9A-FF02-4342-A86C-053F3134F43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1974851"/>
            <a:ext cx="6172200" cy="97472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2A0EDD4-5B28-AE40-8DB8-10A59BF6C7D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9" y="4114800"/>
            <a:ext cx="3932237" cy="7623176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208AD0C-0A36-304F-8E67-A27C45AA33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11B2C1-1F86-8C4D-A04D-EBD4AF1AE7FC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4F8A5D2-1F54-5542-9339-4D52FA683B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D71A33D-030C-9D4C-9EB8-C245156A1F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08BED2-F256-7B49-A262-A1B89828E0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11261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99BACD-50F8-A341-989D-2CEAA0BC73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914400"/>
            <a:ext cx="3932237" cy="32004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E2CC26E-E068-064A-8EE6-BEF53501849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1974851"/>
            <a:ext cx="6172200" cy="974725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3142026-F2CF-1D4F-B018-8B26FCC3778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9" y="4114800"/>
            <a:ext cx="3932237" cy="7623176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7442EF5-4CE4-F249-8EB2-0D9B2E3DFA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11B2C1-1F86-8C4D-A04D-EBD4AF1AE7FC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482703D-B710-A948-9B12-A657C444A8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4C04236-F39F-0149-8B73-5076FEB352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08BED2-F256-7B49-A262-A1B89828E0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31525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9ED06D5-2164-FB43-8CDA-01BA3104DE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730251"/>
            <a:ext cx="10515600" cy="265112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347B926-BB27-C049-BEE8-3BFB2C446A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3651250"/>
            <a:ext cx="10515600" cy="870267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E123890-A8B6-3B46-B731-B103096F5A4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12712701"/>
            <a:ext cx="27432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11B2C1-1F86-8C4D-A04D-EBD4AF1AE7FC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280EE7-F0E6-EB47-A2FE-487F15BDCA3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12712701"/>
            <a:ext cx="41148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463233-9E55-CB4D-A98C-821DBF9EB9B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12712701"/>
            <a:ext cx="27432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08BED2-F256-7B49-A262-A1B89828E0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264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chart" Target="../charts/char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f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f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>
            <a:extLst>
              <a:ext uri="{FF2B5EF4-FFF2-40B4-BE49-F238E27FC236}">
                <a16:creationId xmlns:a16="http://schemas.microsoft.com/office/drawing/2014/main" id="{ABFE344E-FC22-D948-A8BD-1EC49740399C}"/>
              </a:ext>
            </a:extLst>
          </p:cNvPr>
          <p:cNvSpPr txBox="1"/>
          <p:nvPr/>
        </p:nvSpPr>
        <p:spPr>
          <a:xfrm>
            <a:off x="0" y="561691"/>
            <a:ext cx="3749744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Work Area: Floyd Lab – Drake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mage IDs: 346, 351, 353-361, 364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ell Line: HeLa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Overexpression: iBRD4 Isoforms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A9B080D7-B340-4749-AE3D-5FA8A443080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16094" y="5994190"/>
            <a:ext cx="7943117" cy="676010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8C6D45AA-7A8B-AE47-966A-3ED134032C59}"/>
              </a:ext>
            </a:extLst>
          </p:cNvPr>
          <p:cNvSpPr txBox="1"/>
          <p:nvPr/>
        </p:nvSpPr>
        <p:spPr>
          <a:xfrm>
            <a:off x="2014235" y="2818300"/>
            <a:ext cx="177548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BRD4 Iso 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1312590-3F01-8248-B0BC-1EC747C1BBF7}"/>
              </a:ext>
            </a:extLst>
          </p:cNvPr>
          <p:cNvSpPr txBox="1"/>
          <p:nvPr/>
        </p:nvSpPr>
        <p:spPr>
          <a:xfrm>
            <a:off x="1970383" y="3427820"/>
            <a:ext cx="181011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BRD4 Iso C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D49850C-7A27-2746-923A-785FB7F7DA08}"/>
              </a:ext>
            </a:extLst>
          </p:cNvPr>
          <p:cNvSpPr txBox="1"/>
          <p:nvPr/>
        </p:nvSpPr>
        <p:spPr>
          <a:xfrm>
            <a:off x="1996032" y="4075270"/>
            <a:ext cx="175881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RNAPIIpS2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2DAB57A-F35A-AF46-9CF0-89C4EC073221}"/>
              </a:ext>
            </a:extLst>
          </p:cNvPr>
          <p:cNvSpPr txBox="1"/>
          <p:nvPr/>
        </p:nvSpPr>
        <p:spPr>
          <a:xfrm>
            <a:off x="2633540" y="6224003"/>
            <a:ext cx="114326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l-GR" sz="24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H2AX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C8C74B3-E8EB-0045-8E22-D57B80111EF8}"/>
              </a:ext>
            </a:extLst>
          </p:cNvPr>
          <p:cNvSpPr txBox="1"/>
          <p:nvPr/>
        </p:nvSpPr>
        <p:spPr>
          <a:xfrm>
            <a:off x="2591830" y="6935506"/>
            <a:ext cx="11847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36803A2-1C2D-9A48-9B6B-85FF9B0A3881}"/>
              </a:ext>
            </a:extLst>
          </p:cNvPr>
          <p:cNvSpPr txBox="1"/>
          <p:nvPr/>
        </p:nvSpPr>
        <p:spPr>
          <a:xfrm>
            <a:off x="3783340" y="2338109"/>
            <a:ext cx="801693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   0        6       0       6       0       6        0      6       0        6    </a:t>
            </a: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EA5A06CC-CB27-D34F-BCE4-E574BBD935C7}"/>
              </a:ext>
            </a:extLst>
          </p:cNvPr>
          <p:cNvCxnSpPr>
            <a:cxnSpLocks/>
          </p:cNvCxnSpPr>
          <p:nvPr/>
        </p:nvCxnSpPr>
        <p:spPr>
          <a:xfrm>
            <a:off x="3947837" y="2380238"/>
            <a:ext cx="142147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DF8251F9-7D67-EF48-BC20-4985344C5D52}"/>
              </a:ext>
            </a:extLst>
          </p:cNvPr>
          <p:cNvSpPr txBox="1"/>
          <p:nvPr/>
        </p:nvSpPr>
        <p:spPr>
          <a:xfrm>
            <a:off x="5993191" y="1960094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31BD431-1049-B044-AB10-07AE8EBC4C24}"/>
              </a:ext>
            </a:extLst>
          </p:cNvPr>
          <p:cNvSpPr txBox="1"/>
          <p:nvPr/>
        </p:nvSpPr>
        <p:spPr>
          <a:xfrm>
            <a:off x="7453071" y="1960094"/>
            <a:ext cx="40748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4522227-D31A-194D-876C-A2E48001FFF3}"/>
              </a:ext>
            </a:extLst>
          </p:cNvPr>
          <p:cNvSpPr txBox="1"/>
          <p:nvPr/>
        </p:nvSpPr>
        <p:spPr>
          <a:xfrm>
            <a:off x="8601996" y="1916413"/>
            <a:ext cx="121058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A∆CTD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2A262F9-1447-2D49-8B10-84B33B6017F4}"/>
              </a:ext>
            </a:extLst>
          </p:cNvPr>
          <p:cNvSpPr txBox="1"/>
          <p:nvPr/>
        </p:nvSpPr>
        <p:spPr>
          <a:xfrm>
            <a:off x="10275159" y="1916413"/>
            <a:ext cx="98777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C∆ET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7220DF9-3952-D04B-B70B-5AE90886DD1B}"/>
              </a:ext>
            </a:extLst>
          </p:cNvPr>
          <p:cNvSpPr txBox="1"/>
          <p:nvPr/>
        </p:nvSpPr>
        <p:spPr>
          <a:xfrm>
            <a:off x="1124300" y="2303977"/>
            <a:ext cx="269977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10nM dBET6 (hrs)</a:t>
            </a: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F3B388DD-606F-E549-9D13-7E0FF939629E}"/>
              </a:ext>
            </a:extLst>
          </p:cNvPr>
          <p:cNvCxnSpPr>
            <a:cxnSpLocks/>
          </p:cNvCxnSpPr>
          <p:nvPr/>
        </p:nvCxnSpPr>
        <p:spPr>
          <a:xfrm>
            <a:off x="5527254" y="2380238"/>
            <a:ext cx="1321724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9C56C327-31B0-B94E-BE3A-92C02A0F49EE}"/>
              </a:ext>
            </a:extLst>
          </p:cNvPr>
          <p:cNvCxnSpPr>
            <a:cxnSpLocks/>
          </p:cNvCxnSpPr>
          <p:nvPr/>
        </p:nvCxnSpPr>
        <p:spPr>
          <a:xfrm>
            <a:off x="6993295" y="2380238"/>
            <a:ext cx="132703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111E23AC-7EB4-4E4A-A16D-C919FBB71612}"/>
              </a:ext>
            </a:extLst>
          </p:cNvPr>
          <p:cNvCxnSpPr>
            <a:cxnSpLocks/>
          </p:cNvCxnSpPr>
          <p:nvPr/>
        </p:nvCxnSpPr>
        <p:spPr>
          <a:xfrm>
            <a:off x="8589646" y="2380238"/>
            <a:ext cx="123528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1" name="Picture 20">
            <a:extLst>
              <a:ext uri="{FF2B5EF4-FFF2-40B4-BE49-F238E27FC236}">
                <a16:creationId xmlns:a16="http://schemas.microsoft.com/office/drawing/2014/main" id="{58CB1CCD-6669-524E-9CAD-8327A4546C5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07782" y="2785990"/>
            <a:ext cx="7934804" cy="439080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AFE49D30-DD6A-3947-B664-C30A9C5B81F9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3288" b="14240"/>
          <a:stretch/>
        </p:blipFill>
        <p:spPr>
          <a:xfrm>
            <a:off x="3816095" y="3329930"/>
            <a:ext cx="7934804" cy="642671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6B7AFDD0-CF39-DA45-AFC4-56693FAC777A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1025"/>
          <a:stretch/>
        </p:blipFill>
        <p:spPr>
          <a:xfrm>
            <a:off x="3816095" y="4080171"/>
            <a:ext cx="7934804" cy="500562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F25841F7-925D-2A45-A157-DE21B8730A55}"/>
              </a:ext>
            </a:extLst>
          </p:cNvPr>
          <p:cNvSpPr txBox="1"/>
          <p:nvPr/>
        </p:nvSpPr>
        <p:spPr>
          <a:xfrm>
            <a:off x="4284050" y="1922442"/>
            <a:ext cx="74212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dirty="0" err="1">
                <a:latin typeface="Arial" panose="020B0604020202020204" pitchFamily="34" charset="0"/>
                <a:cs typeface="Arial" panose="020B0604020202020204" pitchFamily="34" charset="0"/>
              </a:rPr>
              <a:t>rtTA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43ADBD66-AF42-284A-A0D9-E7C514E98A84}"/>
              </a:ext>
            </a:extLst>
          </p:cNvPr>
          <p:cNvCxnSpPr>
            <a:cxnSpLocks/>
          </p:cNvCxnSpPr>
          <p:nvPr/>
        </p:nvCxnSpPr>
        <p:spPr>
          <a:xfrm>
            <a:off x="10151400" y="2380238"/>
            <a:ext cx="123528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514EA148-0F57-4544-B758-37089E4D397A}"/>
              </a:ext>
            </a:extLst>
          </p:cNvPr>
          <p:cNvSpPr txBox="1"/>
          <p:nvPr/>
        </p:nvSpPr>
        <p:spPr>
          <a:xfrm>
            <a:off x="2735214" y="4873310"/>
            <a:ext cx="100700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BRD2</a:t>
            </a:r>
          </a:p>
        </p:txBody>
      </p:sp>
      <p:pic>
        <p:nvPicPr>
          <p:cNvPr id="29" name="Picture 28">
            <a:extLst>
              <a:ext uri="{FF2B5EF4-FFF2-40B4-BE49-F238E27FC236}">
                <a16:creationId xmlns:a16="http://schemas.microsoft.com/office/drawing/2014/main" id="{4BDC5CBF-F6E9-7F41-992D-7B2FDEC133D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807782" y="6771493"/>
            <a:ext cx="7926491" cy="642294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4BBA4427-CAF7-C145-AA61-4C01C278A89D}"/>
              </a:ext>
            </a:extLst>
          </p:cNvPr>
          <p:cNvSpPr txBox="1"/>
          <p:nvPr/>
        </p:nvSpPr>
        <p:spPr>
          <a:xfrm>
            <a:off x="2769571" y="5512500"/>
            <a:ext cx="100700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BRD3</a:t>
            </a:r>
          </a:p>
        </p:txBody>
      </p:sp>
      <p:pic>
        <p:nvPicPr>
          <p:cNvPr id="31" name="Picture 30">
            <a:extLst>
              <a:ext uri="{FF2B5EF4-FFF2-40B4-BE49-F238E27FC236}">
                <a16:creationId xmlns:a16="http://schemas.microsoft.com/office/drawing/2014/main" id="{FF9DE2B4-4A61-4544-BC8B-A0D564C7685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816094" y="4659514"/>
            <a:ext cx="7951430" cy="581277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AB9ADB98-9335-B241-BDAE-6DADD6EF913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816095" y="5319572"/>
            <a:ext cx="7934804" cy="595837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graphicFrame>
        <p:nvGraphicFramePr>
          <p:cNvPr id="34" name="Chart 33">
            <a:extLst>
              <a:ext uri="{FF2B5EF4-FFF2-40B4-BE49-F238E27FC236}">
                <a16:creationId xmlns:a16="http://schemas.microsoft.com/office/drawing/2014/main" id="{DE9E7F48-527A-9A48-89F6-5CD1BB8FEB7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62621340"/>
              </p:ext>
            </p:extLst>
          </p:nvPr>
        </p:nvGraphicFramePr>
        <p:xfrm>
          <a:off x="3618271" y="7831653"/>
          <a:ext cx="4551952" cy="55816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</p:spTree>
    <p:extLst>
      <p:ext uri="{BB962C8B-B14F-4D97-AF65-F5344CB8AC3E}">
        <p14:creationId xmlns:p14="http://schemas.microsoft.com/office/powerpoint/2010/main" val="672993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>
            <a:extLst>
              <a:ext uri="{FF2B5EF4-FFF2-40B4-BE49-F238E27FC236}">
                <a16:creationId xmlns:a16="http://schemas.microsoft.com/office/drawing/2014/main" id="{ABFE344E-FC22-D948-A8BD-1EC49740399C}"/>
              </a:ext>
            </a:extLst>
          </p:cNvPr>
          <p:cNvSpPr txBox="1"/>
          <p:nvPr/>
        </p:nvSpPr>
        <p:spPr>
          <a:xfrm>
            <a:off x="0" y="561691"/>
            <a:ext cx="3749744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Work Area: Floyd Lab – Drake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mage IDs: 346, 351, 353-361, 364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ell Line: HeLa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Overexpression: iBRD4 Isoform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C6D45AA-7A8B-AE47-966A-3ED134032C59}"/>
              </a:ext>
            </a:extLst>
          </p:cNvPr>
          <p:cNvSpPr txBox="1"/>
          <p:nvPr/>
        </p:nvSpPr>
        <p:spPr>
          <a:xfrm>
            <a:off x="65364" y="3918898"/>
            <a:ext cx="177548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BRD4 Iso 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1312590-3F01-8248-B0BC-1EC747C1BBF7}"/>
              </a:ext>
            </a:extLst>
          </p:cNvPr>
          <p:cNvSpPr txBox="1"/>
          <p:nvPr/>
        </p:nvSpPr>
        <p:spPr>
          <a:xfrm>
            <a:off x="0" y="5090623"/>
            <a:ext cx="181011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BRD4 Iso C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D49850C-7A27-2746-923A-785FB7F7DA08}"/>
              </a:ext>
            </a:extLst>
          </p:cNvPr>
          <p:cNvSpPr txBox="1"/>
          <p:nvPr/>
        </p:nvSpPr>
        <p:spPr>
          <a:xfrm>
            <a:off x="64439" y="3595239"/>
            <a:ext cx="175881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RNAPIIpS2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36803A2-1C2D-9A48-9B6B-85FF9B0A3881}"/>
              </a:ext>
            </a:extLst>
          </p:cNvPr>
          <p:cNvSpPr txBox="1"/>
          <p:nvPr/>
        </p:nvSpPr>
        <p:spPr>
          <a:xfrm>
            <a:off x="3205257" y="2847458"/>
            <a:ext cx="801693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   0        6       0       6       0       6        0      6       0        6    </a:t>
            </a: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EA5A06CC-CB27-D34F-BCE4-E574BBD935C7}"/>
              </a:ext>
            </a:extLst>
          </p:cNvPr>
          <p:cNvCxnSpPr>
            <a:cxnSpLocks/>
          </p:cNvCxnSpPr>
          <p:nvPr/>
        </p:nvCxnSpPr>
        <p:spPr>
          <a:xfrm>
            <a:off x="3369754" y="2889587"/>
            <a:ext cx="142147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DF8251F9-7D67-EF48-BC20-4985344C5D52}"/>
              </a:ext>
            </a:extLst>
          </p:cNvPr>
          <p:cNvSpPr txBox="1"/>
          <p:nvPr/>
        </p:nvSpPr>
        <p:spPr>
          <a:xfrm>
            <a:off x="5415108" y="2469443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31BD431-1049-B044-AB10-07AE8EBC4C24}"/>
              </a:ext>
            </a:extLst>
          </p:cNvPr>
          <p:cNvSpPr txBox="1"/>
          <p:nvPr/>
        </p:nvSpPr>
        <p:spPr>
          <a:xfrm>
            <a:off x="6874988" y="2469443"/>
            <a:ext cx="40748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4522227-D31A-194D-876C-A2E48001FFF3}"/>
              </a:ext>
            </a:extLst>
          </p:cNvPr>
          <p:cNvSpPr txBox="1"/>
          <p:nvPr/>
        </p:nvSpPr>
        <p:spPr>
          <a:xfrm>
            <a:off x="8023913" y="2425762"/>
            <a:ext cx="121058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A∆CTD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2A262F9-1447-2D49-8B10-84B33B6017F4}"/>
              </a:ext>
            </a:extLst>
          </p:cNvPr>
          <p:cNvSpPr txBox="1"/>
          <p:nvPr/>
        </p:nvSpPr>
        <p:spPr>
          <a:xfrm>
            <a:off x="9697076" y="2425762"/>
            <a:ext cx="98777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C∆ET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7220DF9-3952-D04B-B70B-5AE90886DD1B}"/>
              </a:ext>
            </a:extLst>
          </p:cNvPr>
          <p:cNvSpPr txBox="1"/>
          <p:nvPr/>
        </p:nvSpPr>
        <p:spPr>
          <a:xfrm>
            <a:off x="267413" y="2823523"/>
            <a:ext cx="269977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10nM dBET6 (hrs)</a:t>
            </a: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F3B388DD-606F-E549-9D13-7E0FF939629E}"/>
              </a:ext>
            </a:extLst>
          </p:cNvPr>
          <p:cNvCxnSpPr>
            <a:cxnSpLocks/>
          </p:cNvCxnSpPr>
          <p:nvPr/>
        </p:nvCxnSpPr>
        <p:spPr>
          <a:xfrm>
            <a:off x="4949171" y="2889587"/>
            <a:ext cx="1321724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9C56C327-31B0-B94E-BE3A-92C02A0F49EE}"/>
              </a:ext>
            </a:extLst>
          </p:cNvPr>
          <p:cNvCxnSpPr>
            <a:cxnSpLocks/>
          </p:cNvCxnSpPr>
          <p:nvPr/>
        </p:nvCxnSpPr>
        <p:spPr>
          <a:xfrm>
            <a:off x="6415212" y="2889587"/>
            <a:ext cx="132703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111E23AC-7EB4-4E4A-A16D-C919FBB71612}"/>
              </a:ext>
            </a:extLst>
          </p:cNvPr>
          <p:cNvCxnSpPr>
            <a:cxnSpLocks/>
          </p:cNvCxnSpPr>
          <p:nvPr/>
        </p:nvCxnSpPr>
        <p:spPr>
          <a:xfrm>
            <a:off x="8011563" y="2889587"/>
            <a:ext cx="123528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F25841F7-925D-2A45-A157-DE21B8730A55}"/>
              </a:ext>
            </a:extLst>
          </p:cNvPr>
          <p:cNvSpPr txBox="1"/>
          <p:nvPr/>
        </p:nvSpPr>
        <p:spPr>
          <a:xfrm>
            <a:off x="3705967" y="2431791"/>
            <a:ext cx="74212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dirty="0" err="1">
                <a:latin typeface="Arial" panose="020B0604020202020204" pitchFamily="34" charset="0"/>
                <a:cs typeface="Arial" panose="020B0604020202020204" pitchFamily="34" charset="0"/>
              </a:rPr>
              <a:t>rtTA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43ADBD66-AF42-284A-A0D9-E7C514E98A84}"/>
              </a:ext>
            </a:extLst>
          </p:cNvPr>
          <p:cNvCxnSpPr>
            <a:cxnSpLocks/>
          </p:cNvCxnSpPr>
          <p:nvPr/>
        </p:nvCxnSpPr>
        <p:spPr>
          <a:xfrm>
            <a:off x="9573317" y="2889587"/>
            <a:ext cx="123528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" name="Picture 1">
            <a:extLst>
              <a:ext uri="{FF2B5EF4-FFF2-40B4-BE49-F238E27FC236}">
                <a16:creationId xmlns:a16="http://schemas.microsoft.com/office/drawing/2014/main" id="{CEDBF1A9-AC51-2D4F-A5AF-4F78BDC8C38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647" r="2927"/>
          <a:stretch/>
        </p:blipFill>
        <p:spPr>
          <a:xfrm>
            <a:off x="1810112" y="3337846"/>
            <a:ext cx="10025431" cy="2864618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2DD1FADE-6122-DB4C-A7E5-13731A6986C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3917"/>
          <a:stretch/>
        </p:blipFill>
        <p:spPr>
          <a:xfrm>
            <a:off x="10432472" y="7778290"/>
            <a:ext cx="1113559" cy="3365500"/>
          </a:xfrm>
          <a:prstGeom prst="rect">
            <a:avLst/>
          </a:prstGeom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EC34EE24-313E-0D48-8F29-D8FE59CBFB18}"/>
              </a:ext>
            </a:extLst>
          </p:cNvPr>
          <p:cNvSpPr txBox="1"/>
          <p:nvPr/>
        </p:nvSpPr>
        <p:spPr>
          <a:xfrm>
            <a:off x="3522121" y="7051872"/>
            <a:ext cx="456567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BRD4 (green), RNAPIIpS2 (red)</a:t>
            </a:r>
          </a:p>
        </p:txBody>
      </p:sp>
    </p:spTree>
    <p:extLst>
      <p:ext uri="{BB962C8B-B14F-4D97-AF65-F5344CB8AC3E}">
        <p14:creationId xmlns:p14="http://schemas.microsoft.com/office/powerpoint/2010/main" val="249231540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>
            <a:extLst>
              <a:ext uri="{FF2B5EF4-FFF2-40B4-BE49-F238E27FC236}">
                <a16:creationId xmlns:a16="http://schemas.microsoft.com/office/drawing/2014/main" id="{ABFE344E-FC22-D948-A8BD-1EC49740399C}"/>
              </a:ext>
            </a:extLst>
          </p:cNvPr>
          <p:cNvSpPr txBox="1"/>
          <p:nvPr/>
        </p:nvSpPr>
        <p:spPr>
          <a:xfrm>
            <a:off x="0" y="561691"/>
            <a:ext cx="3749744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Work Area: Floyd Lab – Drake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mage IDs: 346, 351, 353-361, 364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ell Line: HeLa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Overexpression: iBRD4 Isoform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36803A2-1C2D-9A48-9B6B-85FF9B0A3881}"/>
              </a:ext>
            </a:extLst>
          </p:cNvPr>
          <p:cNvSpPr txBox="1"/>
          <p:nvPr/>
        </p:nvSpPr>
        <p:spPr>
          <a:xfrm>
            <a:off x="3205257" y="2847458"/>
            <a:ext cx="801693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   0        6       0       6       0       6        0      6       0        6    </a:t>
            </a: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EA5A06CC-CB27-D34F-BCE4-E574BBD935C7}"/>
              </a:ext>
            </a:extLst>
          </p:cNvPr>
          <p:cNvCxnSpPr>
            <a:cxnSpLocks/>
          </p:cNvCxnSpPr>
          <p:nvPr/>
        </p:nvCxnSpPr>
        <p:spPr>
          <a:xfrm>
            <a:off x="3369754" y="2889587"/>
            <a:ext cx="142147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DF8251F9-7D67-EF48-BC20-4985344C5D52}"/>
              </a:ext>
            </a:extLst>
          </p:cNvPr>
          <p:cNvSpPr txBox="1"/>
          <p:nvPr/>
        </p:nvSpPr>
        <p:spPr>
          <a:xfrm>
            <a:off x="5415108" y="2469443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31BD431-1049-B044-AB10-07AE8EBC4C24}"/>
              </a:ext>
            </a:extLst>
          </p:cNvPr>
          <p:cNvSpPr txBox="1"/>
          <p:nvPr/>
        </p:nvSpPr>
        <p:spPr>
          <a:xfrm>
            <a:off x="6874988" y="2469443"/>
            <a:ext cx="40748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4522227-D31A-194D-876C-A2E48001FFF3}"/>
              </a:ext>
            </a:extLst>
          </p:cNvPr>
          <p:cNvSpPr txBox="1"/>
          <p:nvPr/>
        </p:nvSpPr>
        <p:spPr>
          <a:xfrm>
            <a:off x="8023913" y="2425762"/>
            <a:ext cx="121058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A∆CTD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2A262F9-1447-2D49-8B10-84B33B6017F4}"/>
              </a:ext>
            </a:extLst>
          </p:cNvPr>
          <p:cNvSpPr txBox="1"/>
          <p:nvPr/>
        </p:nvSpPr>
        <p:spPr>
          <a:xfrm>
            <a:off x="9697076" y="2425762"/>
            <a:ext cx="98777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C∆ET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7220DF9-3952-D04B-B70B-5AE90886DD1B}"/>
              </a:ext>
            </a:extLst>
          </p:cNvPr>
          <p:cNvSpPr txBox="1"/>
          <p:nvPr/>
        </p:nvSpPr>
        <p:spPr>
          <a:xfrm>
            <a:off x="267413" y="2823523"/>
            <a:ext cx="269977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10nM dBET6 (hrs)</a:t>
            </a: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F3B388DD-606F-E549-9D13-7E0FF939629E}"/>
              </a:ext>
            </a:extLst>
          </p:cNvPr>
          <p:cNvCxnSpPr>
            <a:cxnSpLocks/>
          </p:cNvCxnSpPr>
          <p:nvPr/>
        </p:nvCxnSpPr>
        <p:spPr>
          <a:xfrm>
            <a:off x="4949171" y="2889587"/>
            <a:ext cx="1321724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9C56C327-31B0-B94E-BE3A-92C02A0F49EE}"/>
              </a:ext>
            </a:extLst>
          </p:cNvPr>
          <p:cNvCxnSpPr>
            <a:cxnSpLocks/>
          </p:cNvCxnSpPr>
          <p:nvPr/>
        </p:nvCxnSpPr>
        <p:spPr>
          <a:xfrm>
            <a:off x="6415212" y="2889587"/>
            <a:ext cx="132703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111E23AC-7EB4-4E4A-A16D-C919FBB71612}"/>
              </a:ext>
            </a:extLst>
          </p:cNvPr>
          <p:cNvCxnSpPr>
            <a:cxnSpLocks/>
          </p:cNvCxnSpPr>
          <p:nvPr/>
        </p:nvCxnSpPr>
        <p:spPr>
          <a:xfrm>
            <a:off x="8011563" y="2889587"/>
            <a:ext cx="123528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F25841F7-925D-2A45-A157-DE21B8730A55}"/>
              </a:ext>
            </a:extLst>
          </p:cNvPr>
          <p:cNvSpPr txBox="1"/>
          <p:nvPr/>
        </p:nvSpPr>
        <p:spPr>
          <a:xfrm>
            <a:off x="3705967" y="2431791"/>
            <a:ext cx="74212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dirty="0" err="1">
                <a:latin typeface="Arial" panose="020B0604020202020204" pitchFamily="34" charset="0"/>
                <a:cs typeface="Arial" panose="020B0604020202020204" pitchFamily="34" charset="0"/>
              </a:rPr>
              <a:t>rtTA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43ADBD66-AF42-284A-A0D9-E7C514E98A84}"/>
              </a:ext>
            </a:extLst>
          </p:cNvPr>
          <p:cNvCxnSpPr>
            <a:cxnSpLocks/>
          </p:cNvCxnSpPr>
          <p:nvPr/>
        </p:nvCxnSpPr>
        <p:spPr>
          <a:xfrm>
            <a:off x="9573317" y="2889587"/>
            <a:ext cx="123528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1D49850C-7A27-2746-923A-785FB7F7DA08}"/>
              </a:ext>
            </a:extLst>
          </p:cNvPr>
          <p:cNvSpPr txBox="1"/>
          <p:nvPr/>
        </p:nvSpPr>
        <p:spPr>
          <a:xfrm>
            <a:off x="196224" y="5175250"/>
            <a:ext cx="11847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6B1141E7-62DD-5F48-9C3D-D328D1E6F8A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3917"/>
          <a:stretch/>
        </p:blipFill>
        <p:spPr>
          <a:xfrm>
            <a:off x="267413" y="7526977"/>
            <a:ext cx="1113559" cy="336550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D99127B1-3642-074B-99DD-EA83A77FC3F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28800" y="3557198"/>
            <a:ext cx="10187197" cy="51711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5449742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>
            <a:extLst>
              <a:ext uri="{FF2B5EF4-FFF2-40B4-BE49-F238E27FC236}">
                <a16:creationId xmlns:a16="http://schemas.microsoft.com/office/drawing/2014/main" id="{ABFE344E-FC22-D948-A8BD-1EC49740399C}"/>
              </a:ext>
            </a:extLst>
          </p:cNvPr>
          <p:cNvSpPr txBox="1"/>
          <p:nvPr/>
        </p:nvSpPr>
        <p:spPr>
          <a:xfrm>
            <a:off x="0" y="561691"/>
            <a:ext cx="3749744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Work Area: Floyd Lab – Drake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mage IDs: 346, 351, 353-361, 364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ell Line: HeLa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Overexpression: iBRD4 Isoform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36803A2-1C2D-9A48-9B6B-85FF9B0A3881}"/>
              </a:ext>
            </a:extLst>
          </p:cNvPr>
          <p:cNvSpPr txBox="1"/>
          <p:nvPr/>
        </p:nvSpPr>
        <p:spPr>
          <a:xfrm>
            <a:off x="3205257" y="2847458"/>
            <a:ext cx="801693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   0        6       0       6       0       6        0      6       0        6    </a:t>
            </a: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EA5A06CC-CB27-D34F-BCE4-E574BBD935C7}"/>
              </a:ext>
            </a:extLst>
          </p:cNvPr>
          <p:cNvCxnSpPr>
            <a:cxnSpLocks/>
          </p:cNvCxnSpPr>
          <p:nvPr/>
        </p:nvCxnSpPr>
        <p:spPr>
          <a:xfrm>
            <a:off x="3369754" y="2889587"/>
            <a:ext cx="142147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DF8251F9-7D67-EF48-BC20-4985344C5D52}"/>
              </a:ext>
            </a:extLst>
          </p:cNvPr>
          <p:cNvSpPr txBox="1"/>
          <p:nvPr/>
        </p:nvSpPr>
        <p:spPr>
          <a:xfrm>
            <a:off x="5415108" y="2469443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31BD431-1049-B044-AB10-07AE8EBC4C24}"/>
              </a:ext>
            </a:extLst>
          </p:cNvPr>
          <p:cNvSpPr txBox="1"/>
          <p:nvPr/>
        </p:nvSpPr>
        <p:spPr>
          <a:xfrm>
            <a:off x="6874988" y="2469443"/>
            <a:ext cx="40748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4522227-D31A-194D-876C-A2E48001FFF3}"/>
              </a:ext>
            </a:extLst>
          </p:cNvPr>
          <p:cNvSpPr txBox="1"/>
          <p:nvPr/>
        </p:nvSpPr>
        <p:spPr>
          <a:xfrm>
            <a:off x="8023913" y="2425762"/>
            <a:ext cx="121058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A∆CTD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2A262F9-1447-2D49-8B10-84B33B6017F4}"/>
              </a:ext>
            </a:extLst>
          </p:cNvPr>
          <p:cNvSpPr txBox="1"/>
          <p:nvPr/>
        </p:nvSpPr>
        <p:spPr>
          <a:xfrm>
            <a:off x="9697076" y="2425762"/>
            <a:ext cx="98777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C∆ET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7220DF9-3952-D04B-B70B-5AE90886DD1B}"/>
              </a:ext>
            </a:extLst>
          </p:cNvPr>
          <p:cNvSpPr txBox="1"/>
          <p:nvPr/>
        </p:nvSpPr>
        <p:spPr>
          <a:xfrm>
            <a:off x="267413" y="2823523"/>
            <a:ext cx="269977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10nM dBET6 (hrs)</a:t>
            </a: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F3B388DD-606F-E549-9D13-7E0FF939629E}"/>
              </a:ext>
            </a:extLst>
          </p:cNvPr>
          <p:cNvCxnSpPr>
            <a:cxnSpLocks/>
          </p:cNvCxnSpPr>
          <p:nvPr/>
        </p:nvCxnSpPr>
        <p:spPr>
          <a:xfrm>
            <a:off x="4949171" y="2889587"/>
            <a:ext cx="1321724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9C56C327-31B0-B94E-BE3A-92C02A0F49EE}"/>
              </a:ext>
            </a:extLst>
          </p:cNvPr>
          <p:cNvCxnSpPr>
            <a:cxnSpLocks/>
          </p:cNvCxnSpPr>
          <p:nvPr/>
        </p:nvCxnSpPr>
        <p:spPr>
          <a:xfrm>
            <a:off x="6415212" y="2889587"/>
            <a:ext cx="132703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111E23AC-7EB4-4E4A-A16D-C919FBB71612}"/>
              </a:ext>
            </a:extLst>
          </p:cNvPr>
          <p:cNvCxnSpPr>
            <a:cxnSpLocks/>
          </p:cNvCxnSpPr>
          <p:nvPr/>
        </p:nvCxnSpPr>
        <p:spPr>
          <a:xfrm>
            <a:off x="8011563" y="2889587"/>
            <a:ext cx="123528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F25841F7-925D-2A45-A157-DE21B8730A55}"/>
              </a:ext>
            </a:extLst>
          </p:cNvPr>
          <p:cNvSpPr txBox="1"/>
          <p:nvPr/>
        </p:nvSpPr>
        <p:spPr>
          <a:xfrm>
            <a:off x="3705967" y="2431791"/>
            <a:ext cx="74212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dirty="0" err="1">
                <a:latin typeface="Arial" panose="020B0604020202020204" pitchFamily="34" charset="0"/>
                <a:cs typeface="Arial" panose="020B0604020202020204" pitchFamily="34" charset="0"/>
              </a:rPr>
              <a:t>rtTA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43ADBD66-AF42-284A-A0D9-E7C514E98A84}"/>
              </a:ext>
            </a:extLst>
          </p:cNvPr>
          <p:cNvCxnSpPr>
            <a:cxnSpLocks/>
          </p:cNvCxnSpPr>
          <p:nvPr/>
        </p:nvCxnSpPr>
        <p:spPr>
          <a:xfrm>
            <a:off x="9573317" y="2889587"/>
            <a:ext cx="123528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1D49850C-7A27-2746-923A-785FB7F7DA08}"/>
              </a:ext>
            </a:extLst>
          </p:cNvPr>
          <p:cNvSpPr txBox="1"/>
          <p:nvPr/>
        </p:nvSpPr>
        <p:spPr>
          <a:xfrm>
            <a:off x="800538" y="4849533"/>
            <a:ext cx="100700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BRD2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4D0535D4-A675-CF44-86EE-CA385764DAD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33844" y="3557197"/>
            <a:ext cx="9667605" cy="6369579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E12CF7A5-4651-D24A-9701-3851722B705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3917"/>
          <a:stretch/>
        </p:blipFill>
        <p:spPr>
          <a:xfrm>
            <a:off x="10467121" y="10039203"/>
            <a:ext cx="1113559" cy="3365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4278306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>
            <a:extLst>
              <a:ext uri="{FF2B5EF4-FFF2-40B4-BE49-F238E27FC236}">
                <a16:creationId xmlns:a16="http://schemas.microsoft.com/office/drawing/2014/main" id="{ABFE344E-FC22-D948-A8BD-1EC49740399C}"/>
              </a:ext>
            </a:extLst>
          </p:cNvPr>
          <p:cNvSpPr txBox="1"/>
          <p:nvPr/>
        </p:nvSpPr>
        <p:spPr>
          <a:xfrm>
            <a:off x="0" y="561691"/>
            <a:ext cx="3749744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Work Area: Floyd Lab – Drake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mage IDs: 346, 351, 353-361, 364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ell Line: HeLa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Overexpression: iBRD4 Isoform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36803A2-1C2D-9A48-9B6B-85FF9B0A3881}"/>
              </a:ext>
            </a:extLst>
          </p:cNvPr>
          <p:cNvSpPr txBox="1"/>
          <p:nvPr/>
        </p:nvSpPr>
        <p:spPr>
          <a:xfrm>
            <a:off x="3205257" y="2847458"/>
            <a:ext cx="801693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   0        6       0       6       0       6        0      6       0        6    </a:t>
            </a: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EA5A06CC-CB27-D34F-BCE4-E574BBD935C7}"/>
              </a:ext>
            </a:extLst>
          </p:cNvPr>
          <p:cNvCxnSpPr>
            <a:cxnSpLocks/>
          </p:cNvCxnSpPr>
          <p:nvPr/>
        </p:nvCxnSpPr>
        <p:spPr>
          <a:xfrm>
            <a:off x="3369754" y="2889587"/>
            <a:ext cx="142147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DF8251F9-7D67-EF48-BC20-4985344C5D52}"/>
              </a:ext>
            </a:extLst>
          </p:cNvPr>
          <p:cNvSpPr txBox="1"/>
          <p:nvPr/>
        </p:nvSpPr>
        <p:spPr>
          <a:xfrm>
            <a:off x="5415108" y="2469443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31BD431-1049-B044-AB10-07AE8EBC4C24}"/>
              </a:ext>
            </a:extLst>
          </p:cNvPr>
          <p:cNvSpPr txBox="1"/>
          <p:nvPr/>
        </p:nvSpPr>
        <p:spPr>
          <a:xfrm>
            <a:off x="6874988" y="2469443"/>
            <a:ext cx="40748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4522227-D31A-194D-876C-A2E48001FFF3}"/>
              </a:ext>
            </a:extLst>
          </p:cNvPr>
          <p:cNvSpPr txBox="1"/>
          <p:nvPr/>
        </p:nvSpPr>
        <p:spPr>
          <a:xfrm>
            <a:off x="8023913" y="2425762"/>
            <a:ext cx="121058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A∆CTD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2A262F9-1447-2D49-8B10-84B33B6017F4}"/>
              </a:ext>
            </a:extLst>
          </p:cNvPr>
          <p:cNvSpPr txBox="1"/>
          <p:nvPr/>
        </p:nvSpPr>
        <p:spPr>
          <a:xfrm>
            <a:off x="9697076" y="2425762"/>
            <a:ext cx="98777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C∆ET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7220DF9-3952-D04B-B70B-5AE90886DD1B}"/>
              </a:ext>
            </a:extLst>
          </p:cNvPr>
          <p:cNvSpPr txBox="1"/>
          <p:nvPr/>
        </p:nvSpPr>
        <p:spPr>
          <a:xfrm>
            <a:off x="267413" y="2823523"/>
            <a:ext cx="269977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10nM dBET6 (hrs)</a:t>
            </a: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F3B388DD-606F-E549-9D13-7E0FF939629E}"/>
              </a:ext>
            </a:extLst>
          </p:cNvPr>
          <p:cNvCxnSpPr>
            <a:cxnSpLocks/>
          </p:cNvCxnSpPr>
          <p:nvPr/>
        </p:nvCxnSpPr>
        <p:spPr>
          <a:xfrm>
            <a:off x="4949171" y="2889587"/>
            <a:ext cx="1321724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9C56C327-31B0-B94E-BE3A-92C02A0F49EE}"/>
              </a:ext>
            </a:extLst>
          </p:cNvPr>
          <p:cNvCxnSpPr>
            <a:cxnSpLocks/>
          </p:cNvCxnSpPr>
          <p:nvPr/>
        </p:nvCxnSpPr>
        <p:spPr>
          <a:xfrm>
            <a:off x="6415212" y="2889587"/>
            <a:ext cx="132703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111E23AC-7EB4-4E4A-A16D-C919FBB71612}"/>
              </a:ext>
            </a:extLst>
          </p:cNvPr>
          <p:cNvCxnSpPr>
            <a:cxnSpLocks/>
          </p:cNvCxnSpPr>
          <p:nvPr/>
        </p:nvCxnSpPr>
        <p:spPr>
          <a:xfrm>
            <a:off x="8011563" y="2889587"/>
            <a:ext cx="123528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F25841F7-925D-2A45-A157-DE21B8730A55}"/>
              </a:ext>
            </a:extLst>
          </p:cNvPr>
          <p:cNvSpPr txBox="1"/>
          <p:nvPr/>
        </p:nvSpPr>
        <p:spPr>
          <a:xfrm>
            <a:off x="3705967" y="2431791"/>
            <a:ext cx="74212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dirty="0" err="1">
                <a:latin typeface="Arial" panose="020B0604020202020204" pitchFamily="34" charset="0"/>
                <a:cs typeface="Arial" panose="020B0604020202020204" pitchFamily="34" charset="0"/>
              </a:rPr>
              <a:t>rtTA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43ADBD66-AF42-284A-A0D9-E7C514E98A84}"/>
              </a:ext>
            </a:extLst>
          </p:cNvPr>
          <p:cNvCxnSpPr>
            <a:cxnSpLocks/>
          </p:cNvCxnSpPr>
          <p:nvPr/>
        </p:nvCxnSpPr>
        <p:spPr>
          <a:xfrm>
            <a:off x="9573317" y="2889587"/>
            <a:ext cx="123528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1D49850C-7A27-2746-923A-785FB7F7DA08}"/>
              </a:ext>
            </a:extLst>
          </p:cNvPr>
          <p:cNvSpPr txBox="1"/>
          <p:nvPr/>
        </p:nvSpPr>
        <p:spPr>
          <a:xfrm>
            <a:off x="800538" y="4849533"/>
            <a:ext cx="100700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BRD3</a:t>
            </a: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E12CF7A5-4651-D24A-9701-3851722B705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3917"/>
          <a:stretch/>
        </p:blipFill>
        <p:spPr>
          <a:xfrm>
            <a:off x="693986" y="6547858"/>
            <a:ext cx="1113559" cy="3365500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F458C9B1-FA7B-9A42-AB2F-F9C78B4F664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36633" y="3285187"/>
            <a:ext cx="9387954" cy="70991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6920441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>
            <a:extLst>
              <a:ext uri="{FF2B5EF4-FFF2-40B4-BE49-F238E27FC236}">
                <a16:creationId xmlns:a16="http://schemas.microsoft.com/office/drawing/2014/main" id="{ABFE344E-FC22-D948-A8BD-1EC49740399C}"/>
              </a:ext>
            </a:extLst>
          </p:cNvPr>
          <p:cNvSpPr txBox="1"/>
          <p:nvPr/>
        </p:nvSpPr>
        <p:spPr>
          <a:xfrm>
            <a:off x="0" y="561691"/>
            <a:ext cx="3749744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Work Area: Floyd Lab – Drake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mage IDs: 346, 351, 353-361, 364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ell Line: HeLa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Overexpression: iBRD4 Isoform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36803A2-1C2D-9A48-9B6B-85FF9B0A3881}"/>
              </a:ext>
            </a:extLst>
          </p:cNvPr>
          <p:cNvSpPr txBox="1"/>
          <p:nvPr/>
        </p:nvSpPr>
        <p:spPr>
          <a:xfrm>
            <a:off x="3205257" y="2847458"/>
            <a:ext cx="801693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   0        6       0       6       0       6        0      6       0        6    </a:t>
            </a: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EA5A06CC-CB27-D34F-BCE4-E574BBD935C7}"/>
              </a:ext>
            </a:extLst>
          </p:cNvPr>
          <p:cNvCxnSpPr>
            <a:cxnSpLocks/>
          </p:cNvCxnSpPr>
          <p:nvPr/>
        </p:nvCxnSpPr>
        <p:spPr>
          <a:xfrm>
            <a:off x="3369754" y="2889587"/>
            <a:ext cx="142147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DF8251F9-7D67-EF48-BC20-4985344C5D52}"/>
              </a:ext>
            </a:extLst>
          </p:cNvPr>
          <p:cNvSpPr txBox="1"/>
          <p:nvPr/>
        </p:nvSpPr>
        <p:spPr>
          <a:xfrm>
            <a:off x="5415108" y="2469443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31BD431-1049-B044-AB10-07AE8EBC4C24}"/>
              </a:ext>
            </a:extLst>
          </p:cNvPr>
          <p:cNvSpPr txBox="1"/>
          <p:nvPr/>
        </p:nvSpPr>
        <p:spPr>
          <a:xfrm>
            <a:off x="6874988" y="2469443"/>
            <a:ext cx="40748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4522227-D31A-194D-876C-A2E48001FFF3}"/>
              </a:ext>
            </a:extLst>
          </p:cNvPr>
          <p:cNvSpPr txBox="1"/>
          <p:nvPr/>
        </p:nvSpPr>
        <p:spPr>
          <a:xfrm>
            <a:off x="8023913" y="2425762"/>
            <a:ext cx="121058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A∆CTD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2A262F9-1447-2D49-8B10-84B33B6017F4}"/>
              </a:ext>
            </a:extLst>
          </p:cNvPr>
          <p:cNvSpPr txBox="1"/>
          <p:nvPr/>
        </p:nvSpPr>
        <p:spPr>
          <a:xfrm>
            <a:off x="9697076" y="2425762"/>
            <a:ext cx="98777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C∆ET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7220DF9-3952-D04B-B70B-5AE90886DD1B}"/>
              </a:ext>
            </a:extLst>
          </p:cNvPr>
          <p:cNvSpPr txBox="1"/>
          <p:nvPr/>
        </p:nvSpPr>
        <p:spPr>
          <a:xfrm>
            <a:off x="267413" y="2823523"/>
            <a:ext cx="269977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10nM dBET6 (hrs)</a:t>
            </a: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F3B388DD-606F-E549-9D13-7E0FF939629E}"/>
              </a:ext>
            </a:extLst>
          </p:cNvPr>
          <p:cNvCxnSpPr>
            <a:cxnSpLocks/>
          </p:cNvCxnSpPr>
          <p:nvPr/>
        </p:nvCxnSpPr>
        <p:spPr>
          <a:xfrm>
            <a:off x="4949171" y="2889587"/>
            <a:ext cx="1321724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9C56C327-31B0-B94E-BE3A-92C02A0F49EE}"/>
              </a:ext>
            </a:extLst>
          </p:cNvPr>
          <p:cNvCxnSpPr>
            <a:cxnSpLocks/>
          </p:cNvCxnSpPr>
          <p:nvPr/>
        </p:nvCxnSpPr>
        <p:spPr>
          <a:xfrm>
            <a:off x="6415212" y="2889587"/>
            <a:ext cx="132703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111E23AC-7EB4-4E4A-A16D-C919FBB71612}"/>
              </a:ext>
            </a:extLst>
          </p:cNvPr>
          <p:cNvCxnSpPr>
            <a:cxnSpLocks/>
          </p:cNvCxnSpPr>
          <p:nvPr/>
        </p:nvCxnSpPr>
        <p:spPr>
          <a:xfrm>
            <a:off x="8011563" y="2889587"/>
            <a:ext cx="123528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F25841F7-925D-2A45-A157-DE21B8730A55}"/>
              </a:ext>
            </a:extLst>
          </p:cNvPr>
          <p:cNvSpPr txBox="1"/>
          <p:nvPr/>
        </p:nvSpPr>
        <p:spPr>
          <a:xfrm>
            <a:off x="3705967" y="2431791"/>
            <a:ext cx="74212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dirty="0" err="1">
                <a:latin typeface="Arial" panose="020B0604020202020204" pitchFamily="34" charset="0"/>
                <a:cs typeface="Arial" panose="020B0604020202020204" pitchFamily="34" charset="0"/>
              </a:rPr>
              <a:t>rtTA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43ADBD66-AF42-284A-A0D9-E7C514E98A84}"/>
              </a:ext>
            </a:extLst>
          </p:cNvPr>
          <p:cNvCxnSpPr>
            <a:cxnSpLocks/>
          </p:cNvCxnSpPr>
          <p:nvPr/>
        </p:nvCxnSpPr>
        <p:spPr>
          <a:xfrm>
            <a:off x="9573317" y="2889587"/>
            <a:ext cx="123528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1D49850C-7A27-2746-923A-785FB7F7DA08}"/>
              </a:ext>
            </a:extLst>
          </p:cNvPr>
          <p:cNvSpPr txBox="1"/>
          <p:nvPr/>
        </p:nvSpPr>
        <p:spPr>
          <a:xfrm>
            <a:off x="561691" y="4416406"/>
            <a:ext cx="12458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l-GR" sz="24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H2AX </a:t>
            </a: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E12CF7A5-4651-D24A-9701-3851722B705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3917"/>
          <a:stretch/>
        </p:blipFill>
        <p:spPr>
          <a:xfrm>
            <a:off x="304800" y="5778931"/>
            <a:ext cx="1113559" cy="336550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3D70D7E2-22DF-A042-87A2-A19821BCD19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07545" y="3346775"/>
            <a:ext cx="10079655" cy="51795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48807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6</TotalTime>
  <Words>350</Words>
  <Application>Microsoft Macintosh PowerPoint</Application>
  <PresentationFormat>Custom</PresentationFormat>
  <Paragraphs>84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ake Edwards</dc:creator>
  <cp:lastModifiedBy>Drake Edwards</cp:lastModifiedBy>
  <cp:revision>11</cp:revision>
  <dcterms:created xsi:type="dcterms:W3CDTF">2019-11-01T13:09:45Z</dcterms:created>
  <dcterms:modified xsi:type="dcterms:W3CDTF">2019-11-24T19:04:26Z</dcterms:modified>
</cp:coreProperties>
</file>